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5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>
      <p:cViewPr varScale="1">
        <p:scale>
          <a:sx n="120" d="100"/>
          <a:sy n="120" d="100"/>
        </p:scale>
        <p:origin x="8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nih-my.sharepoint.com/personal/krauzeav_nih_gov1/Documents/CSBB/CSBB%20analysis/signal%20summar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2</c:f>
              <c:strCache>
                <c:ptCount val="1"/>
                <c:pt idx="0">
                  <c:v>Pr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B$3:$B$14</c:f>
              <c:strCache>
                <c:ptCount val="12"/>
                <c:pt idx="0">
                  <c:v>OS</c:v>
                </c:pt>
                <c:pt idx="1">
                  <c:v>PFS</c:v>
                </c:pt>
                <c:pt idx="2">
                  <c:v>MGMT</c:v>
                </c:pt>
                <c:pt idx="3">
                  <c:v>IDH</c:v>
                </c:pt>
                <c:pt idx="4">
                  <c:v>OS </c:v>
                </c:pt>
                <c:pt idx="5">
                  <c:v>PFS </c:v>
                </c:pt>
                <c:pt idx="6">
                  <c:v>MGMT </c:v>
                </c:pt>
                <c:pt idx="7">
                  <c:v>IDH</c:v>
                </c:pt>
                <c:pt idx="8">
                  <c:v>OS </c:v>
                </c:pt>
                <c:pt idx="9">
                  <c:v>PFS </c:v>
                </c:pt>
                <c:pt idx="10">
                  <c:v>MGMT </c:v>
                </c:pt>
                <c:pt idx="11">
                  <c:v>IDH</c:v>
                </c:pt>
              </c:strCache>
            </c:strRef>
          </c:cat>
          <c:val>
            <c:numRef>
              <c:f>Sheet1!$C$3:$C$14</c:f>
              <c:numCache>
                <c:formatCode>General</c:formatCode>
                <c:ptCount val="12"/>
                <c:pt idx="0">
                  <c:v>441</c:v>
                </c:pt>
                <c:pt idx="1">
                  <c:v>864</c:v>
                </c:pt>
                <c:pt idx="2">
                  <c:v>363</c:v>
                </c:pt>
                <c:pt idx="3">
                  <c:v>410</c:v>
                </c:pt>
                <c:pt idx="4">
                  <c:v>672</c:v>
                </c:pt>
                <c:pt idx="5">
                  <c:v>533</c:v>
                </c:pt>
                <c:pt idx="6">
                  <c:v>100</c:v>
                </c:pt>
                <c:pt idx="7">
                  <c:v>337</c:v>
                </c:pt>
                <c:pt idx="8">
                  <c:v>14</c:v>
                </c:pt>
                <c:pt idx="9">
                  <c:v>29</c:v>
                </c:pt>
                <c:pt idx="10">
                  <c:v>9</c:v>
                </c:pt>
                <c:pt idx="11">
                  <c:v>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8A-AE4C-8E95-311FF985C3DE}"/>
            </c:ext>
          </c:extLst>
        </c:ser>
        <c:ser>
          <c:idx val="1"/>
          <c:order val="1"/>
          <c:tx>
            <c:strRef>
              <c:f>Sheet1!$D$2</c:f>
              <c:strCache>
                <c:ptCount val="1"/>
                <c:pt idx="0">
                  <c:v>Al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dLbl>
              <c:idx val="11"/>
              <c:tx>
                <c:rich>
                  <a:bodyPr/>
                  <a:lstStyle/>
                  <a:p>
                    <a:r>
                      <a:rPr lang="en-US"/>
                      <a:t>12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0-E83D-7E44-80B4-2888E60A4A9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B$3:$B$14</c:f>
              <c:strCache>
                <c:ptCount val="12"/>
                <c:pt idx="0">
                  <c:v>OS</c:v>
                </c:pt>
                <c:pt idx="1">
                  <c:v>PFS</c:v>
                </c:pt>
                <c:pt idx="2">
                  <c:v>MGMT</c:v>
                </c:pt>
                <c:pt idx="3">
                  <c:v>IDH</c:v>
                </c:pt>
                <c:pt idx="4">
                  <c:v>OS </c:v>
                </c:pt>
                <c:pt idx="5">
                  <c:v>PFS </c:v>
                </c:pt>
                <c:pt idx="6">
                  <c:v>MGMT </c:v>
                </c:pt>
                <c:pt idx="7">
                  <c:v>IDH</c:v>
                </c:pt>
                <c:pt idx="8">
                  <c:v>OS </c:v>
                </c:pt>
                <c:pt idx="9">
                  <c:v>PFS </c:v>
                </c:pt>
                <c:pt idx="10">
                  <c:v>MGMT </c:v>
                </c:pt>
                <c:pt idx="11">
                  <c:v>IDH</c:v>
                </c:pt>
              </c:strCache>
            </c:strRef>
          </c:cat>
          <c:val>
            <c:numRef>
              <c:f>Sheet1!$D$3:$D$14</c:f>
              <c:numCache>
                <c:formatCode>General</c:formatCode>
                <c:ptCount val="12"/>
                <c:pt idx="0">
                  <c:v>344</c:v>
                </c:pt>
                <c:pt idx="1">
                  <c:v>728</c:v>
                </c:pt>
                <c:pt idx="2">
                  <c:v>170</c:v>
                </c:pt>
                <c:pt idx="3">
                  <c:v>476</c:v>
                </c:pt>
                <c:pt idx="4">
                  <c:v>543</c:v>
                </c:pt>
                <c:pt idx="5">
                  <c:v>306</c:v>
                </c:pt>
                <c:pt idx="6">
                  <c:v>130</c:v>
                </c:pt>
                <c:pt idx="7">
                  <c:v>383</c:v>
                </c:pt>
                <c:pt idx="8">
                  <c:v>19</c:v>
                </c:pt>
                <c:pt idx="9">
                  <c:v>15</c:v>
                </c:pt>
                <c:pt idx="10">
                  <c:v>12</c:v>
                </c:pt>
                <c:pt idx="11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58A-AE4C-8E95-311FF985C3DE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31719168"/>
        <c:axId val="431721296"/>
      </c:barChart>
      <c:catAx>
        <c:axId val="431719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1721296"/>
        <c:crosses val="autoZero"/>
        <c:auto val="1"/>
        <c:lblAlgn val="ctr"/>
        <c:lblOffset val="100"/>
        <c:noMultiLvlLbl val="0"/>
      </c:catAx>
      <c:valAx>
        <c:axId val="4317212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17191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C32508-26DA-0047-B9B5-71236AC1EA4F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EFCFE3-5539-B942-BA78-098173C097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9629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1E53B9-108B-0040-BC42-249C7F3D281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9874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D03AC9-4B83-F53E-F576-973A93FAAA1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99983DE-C9A4-0C29-8644-5AE3B85F67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9110A8-CF5A-8E06-0652-17B1F86D09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C42FD-E499-9F40-9F0C-2FFFDABDECA2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880750-8BB2-D8DF-6639-1A98A627E0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57915B-6507-D173-86D6-E2AF77BF09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DFD15-B0C4-1549-ABC3-8539BE1B1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9158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19D049-2525-7D35-B406-7D74A0BB6B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19A6C5-F32C-51E2-1FC6-988E0D42E0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FDF016-5C48-3802-BDFC-4F72A7BC00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C42FD-E499-9F40-9F0C-2FFFDABDECA2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FC3FBF-8856-DB5F-8628-6921280213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86D822-E594-8FD7-D837-6C41C9B2F8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DFD15-B0C4-1549-ABC3-8539BE1B1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512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77BE51E-C522-ADEF-4A64-F8BFD50391A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5D16F6-7AA9-A4C4-22E8-CBA1F140D3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ACFA42-B18E-34C7-4CE3-63D5FA8F2C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C42FD-E499-9F40-9F0C-2FFFDABDECA2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BB310C-B930-A063-8896-9E8F72367E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40FCBC-FD5D-72B5-EC50-A3A865CB03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DFD15-B0C4-1549-ABC3-8539BE1B1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7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EA5287-DA21-6092-818F-B0266D8AF5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76E9F3-A0DF-5EDD-D738-0B55CBD6D1C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689636-28DE-7B2D-892B-5E3FF592F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C42FD-E499-9F40-9F0C-2FFFDABDECA2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EA18A5-9388-250D-D699-D62D7D4B1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FE0ED2-2046-7416-9BA5-A6A06FF6A2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DFD15-B0C4-1549-ABC3-8539BE1B1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94036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BCD46A-80BC-DD12-1F4F-7A79D52090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D2A0FB-C08E-8D94-A750-05B37DB7F6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D42BC1-F3B8-EF20-1AEC-9E234E6B97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C42FD-E499-9F40-9F0C-2FFFDABDECA2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99CE4E-45FE-1282-AD48-BD1173E98B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A06A28-62B4-223E-7BA7-9E65F29856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DFD15-B0C4-1549-ABC3-8539BE1B1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436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2BAC59-1152-5CE6-9915-A69AA49E96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428650-C03E-D26D-61EF-027BF476B0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2199DA-ECBA-B921-D47E-D52210C954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FBFA9B-0B7A-DCE0-DDD1-DD3BA69F10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C42FD-E499-9F40-9F0C-2FFFDABDECA2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DA2310-BBDD-1BFE-BB77-1E68520B2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6BBA3F-04F0-3D0E-CF3D-8B21479A2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DFD15-B0C4-1549-ABC3-8539BE1B1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8322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7CF3F9-D25A-10E9-BAF3-F5FA035F21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5B3C96-8243-5E69-5106-D1E1C3CCCC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378138-223F-713D-992F-DA4AFB3139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F8137B5-2C8F-0787-4040-247AC24FBB0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7B31CB2-CAD4-7EEA-8CF1-E0435A5264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A571C7E-46FC-0CAA-6507-8CAC24E38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C42FD-E499-9F40-9F0C-2FFFDABDECA2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197A36B-B980-E9B7-C7F8-0455C5ACA3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230DF8-AF81-70BC-4A7A-025271C5A5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DFD15-B0C4-1549-ABC3-8539BE1B1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3534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9CA1A7-B6FD-D8BC-2822-86490D0539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F039C12-65DC-F23D-C840-2E05BEF572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C42FD-E499-9F40-9F0C-2FFFDABDECA2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1CAE7B-2724-1D4F-DDA2-4749FE986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659B9AF-B944-34F7-43D9-8DDB6ED4E2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DFD15-B0C4-1549-ABC3-8539BE1B1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474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AB3C090-EB0F-3DC7-A909-086AE523EF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C42FD-E499-9F40-9F0C-2FFFDABDECA2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E913569-B22E-7E3A-5D3A-054F3C46C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3523A4E-A46B-E99B-E1CA-FC637FA0D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DFD15-B0C4-1549-ABC3-8539BE1B1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2278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7F23DF-2F49-7730-33A5-E8F151F932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2EE75B-39F3-4653-CB88-C51629B8CD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B3DC01-AF83-AE1F-BA54-A63064FC3B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424184-8898-8F1E-5212-77E8759233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C42FD-E499-9F40-9F0C-2FFFDABDECA2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4CF3F5-B1C6-38A9-BD5E-7BD0877084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954182-3E07-D600-5721-42D2292EC9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DFD15-B0C4-1549-ABC3-8539BE1B1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1347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BE299A-4C7B-3A80-D6E3-A784DAA651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A2AB8F0-2D69-A1E8-70B2-E766EB49BE7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456F5B-7C7E-896E-54F2-91E0D74255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714EE1-45DC-5E88-91CB-C5C8A6F887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C42FD-E499-9F40-9F0C-2FFFDABDECA2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DA51C3-6E05-6026-63D4-D899DB143F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302412-8AF6-B99C-7842-0962A4322B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1DFD15-B0C4-1549-ABC3-8539BE1B1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111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AF3D416-C148-2C6A-EA79-ACA35EDD9C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C26A12-FE90-0018-FD07-11E023EE1F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DB70FA-10E0-F02C-6397-740E3B66AB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41C42FD-E499-9F40-9F0C-2FFFDABDECA2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22BBE4-B41B-9BBE-AC2D-34D553C8CE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E544B5-CD82-4AEF-1151-70A565082C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F1DFD15-B0C4-1549-ABC3-8539BE1B1F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7022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5A66FA0-1CCC-740F-767E-4B85802330D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29BC092D-EB57-BDFE-1F8A-DDD831062EF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480794"/>
              </p:ext>
            </p:extLst>
          </p:nvPr>
        </p:nvGraphicFramePr>
        <p:xfrm>
          <a:off x="2514406" y="127600"/>
          <a:ext cx="7522733" cy="55999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itle 1">
            <a:extLst>
              <a:ext uri="{FF2B5EF4-FFF2-40B4-BE49-F238E27FC236}">
                <a16:creationId xmlns:a16="http://schemas.microsoft.com/office/drawing/2014/main" id="{9FE8EFF7-E1F3-66E3-B705-E11C69C2A897}"/>
              </a:ext>
            </a:extLst>
          </p:cNvPr>
          <p:cNvSpPr txBox="1">
            <a:spLocks/>
          </p:cNvSpPr>
          <p:nvPr/>
        </p:nvSpPr>
        <p:spPr>
          <a:xfrm>
            <a:off x="2024592" y="353484"/>
            <a:ext cx="9412817" cy="874183"/>
          </a:xfrm>
          <a:prstGeom prst="rect">
            <a:avLst/>
          </a:prstGeom>
        </p:spPr>
        <p:txBody>
          <a:bodyPr>
            <a:normAutofit fontScale="97500"/>
          </a:bodyPr>
          <a:lstStyle>
            <a:lvl1pPr marL="0" marR="0" indent="0" algn="l" defTabSz="2438338" rtl="0" latinLnBrk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500" b="1" i="0" u="none" strike="noStrike" cap="none" spc="-170" baseline="0">
                <a:solidFill>
                  <a:srgbClr val="000000"/>
                </a:solidFill>
                <a:uFillTx/>
                <a:latin typeface="+mn-lt"/>
                <a:ea typeface="+mn-ea"/>
                <a:cs typeface="+mn-cs"/>
                <a:sym typeface="Helvetica Neue"/>
              </a:defRPr>
            </a:lvl1pPr>
            <a:lvl2pPr marL="0" marR="0" indent="457200" algn="l" defTabSz="2438338" rtl="0" latinLnBrk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500" b="1" i="0" u="none" strike="noStrike" cap="none" spc="-170" baseline="0">
                <a:solidFill>
                  <a:srgbClr val="000000"/>
                </a:solidFill>
                <a:uFillTx/>
                <a:latin typeface="+mn-lt"/>
                <a:ea typeface="+mn-ea"/>
                <a:cs typeface="+mn-cs"/>
                <a:sym typeface="Helvetica Neue"/>
              </a:defRPr>
            </a:lvl2pPr>
            <a:lvl3pPr marL="0" marR="0" indent="914400" algn="l" defTabSz="2438338" rtl="0" latinLnBrk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500" b="1" i="0" u="none" strike="noStrike" cap="none" spc="-170" baseline="0">
                <a:solidFill>
                  <a:srgbClr val="000000"/>
                </a:solidFill>
                <a:uFillTx/>
                <a:latin typeface="+mn-lt"/>
                <a:ea typeface="+mn-ea"/>
                <a:cs typeface="+mn-cs"/>
                <a:sym typeface="Helvetica Neue"/>
              </a:defRPr>
            </a:lvl3pPr>
            <a:lvl4pPr marL="0" marR="0" indent="1371600" algn="l" defTabSz="2438338" rtl="0" latinLnBrk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500" b="1" i="0" u="none" strike="noStrike" cap="none" spc="-170" baseline="0">
                <a:solidFill>
                  <a:srgbClr val="000000"/>
                </a:solidFill>
                <a:uFillTx/>
                <a:latin typeface="+mn-lt"/>
                <a:ea typeface="+mn-ea"/>
                <a:cs typeface="+mn-cs"/>
                <a:sym typeface="Helvetica Neue"/>
              </a:defRPr>
            </a:lvl4pPr>
            <a:lvl5pPr marL="0" marR="0" indent="1828800" algn="l" defTabSz="2438338" rtl="0" latinLnBrk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500" b="1" i="0" u="none" strike="noStrike" cap="none" spc="-170" baseline="0">
                <a:solidFill>
                  <a:srgbClr val="000000"/>
                </a:solidFill>
                <a:uFillTx/>
                <a:latin typeface="+mn-lt"/>
                <a:ea typeface="+mn-ea"/>
                <a:cs typeface="+mn-cs"/>
                <a:sym typeface="Helvetica Neue"/>
              </a:defRPr>
            </a:lvl5pPr>
            <a:lvl6pPr marL="0" marR="0" indent="2286000" algn="l" defTabSz="2438338" rtl="0" latinLnBrk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500" b="1" i="0" u="none" strike="noStrike" cap="none" spc="-170" baseline="0">
                <a:solidFill>
                  <a:srgbClr val="000000"/>
                </a:solidFill>
                <a:uFillTx/>
                <a:latin typeface="+mn-lt"/>
                <a:ea typeface="+mn-ea"/>
                <a:cs typeface="+mn-cs"/>
                <a:sym typeface="Helvetica Neue"/>
              </a:defRPr>
            </a:lvl6pPr>
            <a:lvl7pPr marL="0" marR="0" indent="2743200" algn="l" defTabSz="2438338" rtl="0" latinLnBrk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500" b="1" i="0" u="none" strike="noStrike" cap="none" spc="-170" baseline="0">
                <a:solidFill>
                  <a:srgbClr val="000000"/>
                </a:solidFill>
                <a:uFillTx/>
                <a:latin typeface="+mn-lt"/>
                <a:ea typeface="+mn-ea"/>
                <a:cs typeface="+mn-cs"/>
                <a:sym typeface="Helvetica Neue"/>
              </a:defRPr>
            </a:lvl7pPr>
            <a:lvl8pPr marL="0" marR="0" indent="3200400" algn="l" defTabSz="2438338" rtl="0" latinLnBrk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500" b="1" i="0" u="none" strike="noStrike" cap="none" spc="-170" baseline="0">
                <a:solidFill>
                  <a:srgbClr val="000000"/>
                </a:solidFill>
                <a:uFillTx/>
                <a:latin typeface="+mn-lt"/>
                <a:ea typeface="+mn-ea"/>
                <a:cs typeface="+mn-cs"/>
                <a:sym typeface="Helvetica Neue"/>
              </a:defRPr>
            </a:lvl8pPr>
            <a:lvl9pPr marL="0" marR="0" indent="3657600" algn="l" defTabSz="2438338" rtl="0" latinLnBrk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8500" b="1" i="0" u="none" strike="noStrike" cap="none" spc="-170" baseline="0">
                <a:solidFill>
                  <a:srgbClr val="000000"/>
                </a:solidFill>
                <a:uFillTx/>
                <a:latin typeface="+mn-lt"/>
                <a:ea typeface="+mn-ea"/>
                <a:cs typeface="+mn-cs"/>
                <a:sym typeface="Helvetica Neue"/>
              </a:defRPr>
            </a:lvl9pPr>
          </a:lstStyle>
          <a:p>
            <a:pPr hangingPunct="1"/>
            <a:endParaRPr lang="en-US" sz="2700" dirty="0">
              <a:solidFill>
                <a:schemeClr val="bg2">
                  <a:lumMod val="10000"/>
                </a:schemeClr>
              </a:solidFill>
            </a:endParaRPr>
          </a:p>
        </p:txBody>
      </p:sp>
      <p:sp>
        <p:nvSpPr>
          <p:cNvPr id="13" name="Slide Number Placeholder 12">
            <a:extLst>
              <a:ext uri="{FF2B5EF4-FFF2-40B4-BE49-F238E27FC236}">
                <a16:creationId xmlns:a16="http://schemas.microsoft.com/office/drawing/2014/main" id="{09A3CA27-2078-6E86-67B7-08B60BE881B0}"/>
              </a:ext>
            </a:extLst>
          </p:cNvPr>
          <p:cNvSpPr>
            <a:spLocks noGrp="1"/>
          </p:cNvSpPr>
          <p:nvPr>
            <p:ph type="sldNum" sz="quarter" idx="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 anchor="b">
            <a:spAutoFit/>
          </a:bodyPr>
          <a:lstStyle>
            <a:defPPr marL="0" marR="0" indent="0" algn="l" defTabSz="914400" rtl="0" fontAlgn="auto" latinLnBrk="1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kumimoji="0" sz="18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</a:defRPr>
            </a:defPPr>
            <a:lvl1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kumimoji="0" sz="18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+mn-ea"/>
                <a:cs typeface="+mn-cs"/>
                <a:sym typeface="Helvetica Neue"/>
              </a:defRPr>
            </a:lvl1pPr>
            <a:lvl2pPr marL="0" marR="0" indent="457200" algn="ctr" defTabSz="2438338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kumimoji="0" sz="2400" b="0" i="0" u="none" strike="noStrike" cap="none" spc="0" normalizeH="0" baseline="0">
                <a:ln>
                  <a:noFill/>
                </a:ln>
                <a:solidFill>
                  <a:srgbClr val="5E5E5E"/>
                </a:solidFill>
                <a:effectLst/>
                <a:uFillTx/>
                <a:latin typeface="+mn-lt"/>
                <a:ea typeface="+mn-ea"/>
                <a:cs typeface="+mn-cs"/>
                <a:sym typeface="Helvetica Neue"/>
              </a:defRPr>
            </a:lvl2pPr>
            <a:lvl3pPr marL="0" marR="0" indent="914400" algn="ctr" defTabSz="2438338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kumimoji="0" sz="2400" b="0" i="0" u="none" strike="noStrike" cap="none" spc="0" normalizeH="0" baseline="0">
                <a:ln>
                  <a:noFill/>
                </a:ln>
                <a:solidFill>
                  <a:srgbClr val="5E5E5E"/>
                </a:solidFill>
                <a:effectLst/>
                <a:uFillTx/>
                <a:latin typeface="+mn-lt"/>
                <a:ea typeface="+mn-ea"/>
                <a:cs typeface="+mn-cs"/>
                <a:sym typeface="Helvetica Neue"/>
              </a:defRPr>
            </a:lvl3pPr>
            <a:lvl4pPr marL="0" marR="0" indent="1371600" algn="ctr" defTabSz="2438338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kumimoji="0" sz="2400" b="0" i="0" u="none" strike="noStrike" cap="none" spc="0" normalizeH="0" baseline="0">
                <a:ln>
                  <a:noFill/>
                </a:ln>
                <a:solidFill>
                  <a:srgbClr val="5E5E5E"/>
                </a:solidFill>
                <a:effectLst/>
                <a:uFillTx/>
                <a:latin typeface="+mn-lt"/>
                <a:ea typeface="+mn-ea"/>
                <a:cs typeface="+mn-cs"/>
                <a:sym typeface="Helvetica Neue"/>
              </a:defRPr>
            </a:lvl4pPr>
            <a:lvl5pPr marL="0" marR="0" indent="1828800" algn="ctr" defTabSz="2438338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kumimoji="0" sz="2400" b="0" i="0" u="none" strike="noStrike" cap="none" spc="0" normalizeH="0" baseline="0">
                <a:ln>
                  <a:noFill/>
                </a:ln>
                <a:solidFill>
                  <a:srgbClr val="5E5E5E"/>
                </a:solidFill>
                <a:effectLst/>
                <a:uFillTx/>
                <a:latin typeface="+mn-lt"/>
                <a:ea typeface="+mn-ea"/>
                <a:cs typeface="+mn-cs"/>
                <a:sym typeface="Helvetica Neue"/>
              </a:defRPr>
            </a:lvl5pPr>
            <a:lvl6pPr marL="0" marR="0" indent="2286000" algn="ctr" defTabSz="2438338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kumimoji="0" sz="2400" b="0" i="0" u="none" strike="noStrike" cap="none" spc="0" normalizeH="0" baseline="0">
                <a:ln>
                  <a:noFill/>
                </a:ln>
                <a:solidFill>
                  <a:srgbClr val="5E5E5E"/>
                </a:solidFill>
                <a:effectLst/>
                <a:uFillTx/>
                <a:latin typeface="+mn-lt"/>
                <a:ea typeface="+mn-ea"/>
                <a:cs typeface="+mn-cs"/>
                <a:sym typeface="Helvetica Neue"/>
              </a:defRPr>
            </a:lvl6pPr>
            <a:lvl7pPr marL="0" marR="0" indent="2743200" algn="ctr" defTabSz="2438338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kumimoji="0" sz="2400" b="0" i="0" u="none" strike="noStrike" cap="none" spc="0" normalizeH="0" baseline="0">
                <a:ln>
                  <a:noFill/>
                </a:ln>
                <a:solidFill>
                  <a:srgbClr val="5E5E5E"/>
                </a:solidFill>
                <a:effectLst/>
                <a:uFillTx/>
                <a:latin typeface="+mn-lt"/>
                <a:ea typeface="+mn-ea"/>
                <a:cs typeface="+mn-cs"/>
                <a:sym typeface="Helvetica Neue"/>
              </a:defRPr>
            </a:lvl7pPr>
            <a:lvl8pPr marL="0" marR="0" indent="3200400" algn="ctr" defTabSz="2438338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kumimoji="0" sz="2400" b="0" i="0" u="none" strike="noStrike" cap="none" spc="0" normalizeH="0" baseline="0">
                <a:ln>
                  <a:noFill/>
                </a:ln>
                <a:solidFill>
                  <a:srgbClr val="5E5E5E"/>
                </a:solidFill>
                <a:effectLst/>
                <a:uFillTx/>
                <a:latin typeface="+mn-lt"/>
                <a:ea typeface="+mn-ea"/>
                <a:cs typeface="+mn-cs"/>
                <a:sym typeface="Helvetica Neue"/>
              </a:defRPr>
            </a:lvl8pPr>
            <a:lvl9pPr marL="0" marR="0" indent="3657600" algn="ctr" defTabSz="2438338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kumimoji="0" sz="2400" b="0" i="0" u="none" strike="noStrike" cap="none" spc="0" normalizeH="0" baseline="0">
                <a:ln>
                  <a:noFill/>
                </a:ln>
                <a:solidFill>
                  <a:srgbClr val="5E5E5E"/>
                </a:solidFill>
                <a:effectLst/>
                <a:uFillTx/>
                <a:latin typeface="+mn-lt"/>
                <a:ea typeface="+mn-ea"/>
                <a:cs typeface="+mn-cs"/>
                <a:sym typeface="Helvetica Neue"/>
              </a:defRPr>
            </a:lvl9pPr>
          </a:lstStyle>
          <a:p>
            <a:fld id="{86CB4B4D-7CA3-9044-876B-883B54F8677D}" type="slidenum">
              <a:rPr lang="en-US" smtClean="0"/>
              <a:pPr/>
              <a:t>1</a:t>
            </a:fld>
            <a:endParaRPr lang="en-US"/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28996092-FA37-5743-BD4F-B17F56791392}"/>
              </a:ext>
            </a:extLst>
          </p:cNvPr>
          <p:cNvCxnSpPr/>
          <p:nvPr/>
        </p:nvCxnSpPr>
        <p:spPr>
          <a:xfrm>
            <a:off x="2862943" y="5849620"/>
            <a:ext cx="22098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FA18DBEB-EF8B-D0BD-245F-3B51B9CD47F3}"/>
              </a:ext>
            </a:extLst>
          </p:cNvPr>
          <p:cNvCxnSpPr/>
          <p:nvPr/>
        </p:nvCxnSpPr>
        <p:spPr>
          <a:xfrm>
            <a:off x="5270708" y="5853611"/>
            <a:ext cx="22098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FFFE51FC-4FB4-8AF1-922F-B88C624C415A}"/>
              </a:ext>
            </a:extLst>
          </p:cNvPr>
          <p:cNvCxnSpPr/>
          <p:nvPr/>
        </p:nvCxnSpPr>
        <p:spPr>
          <a:xfrm>
            <a:off x="7678725" y="5849620"/>
            <a:ext cx="22098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A2753AE4-0F8F-11D8-20D1-004BA5BF9635}"/>
              </a:ext>
            </a:extLst>
          </p:cNvPr>
          <p:cNvSpPr txBox="1"/>
          <p:nvPr/>
        </p:nvSpPr>
        <p:spPr>
          <a:xfrm>
            <a:off x="3174196" y="5930847"/>
            <a:ext cx="15872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roteome (7289 proteins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38044A3-069F-1B6B-263B-C95FE8A52077}"/>
              </a:ext>
            </a:extLst>
          </p:cNvPr>
          <p:cNvSpPr txBox="1"/>
          <p:nvPr/>
        </p:nvSpPr>
        <p:spPr>
          <a:xfrm>
            <a:off x="5398417" y="5947822"/>
            <a:ext cx="19543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etabolome (6015 compounds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B60C1D9-4ABF-3EAF-3C02-CEAD733559FD}"/>
              </a:ext>
            </a:extLst>
          </p:cNvPr>
          <p:cNvSpPr txBox="1"/>
          <p:nvPr/>
        </p:nvSpPr>
        <p:spPr>
          <a:xfrm>
            <a:off x="7754336" y="5947822"/>
            <a:ext cx="22653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etabolome (318 level 1 compounds)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4130C42D-E311-9660-AF21-192B395E94B9}"/>
              </a:ext>
            </a:extLst>
          </p:cNvPr>
          <p:cNvGrpSpPr/>
          <p:nvPr/>
        </p:nvGrpSpPr>
        <p:grpSpPr>
          <a:xfrm>
            <a:off x="6271598" y="840941"/>
            <a:ext cx="4662740" cy="773451"/>
            <a:chOff x="676308" y="2891714"/>
            <a:chExt cx="4662740" cy="773451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C3274E39-494D-D521-1467-AD3A6751D59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46989" t="96171" r="51853" b="2232"/>
            <a:stretch>
              <a:fillRect/>
            </a:stretch>
          </p:blipFill>
          <p:spPr>
            <a:xfrm>
              <a:off x="680482" y="2898515"/>
              <a:ext cx="333783" cy="333783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BB086F54-E8F0-87A9-F2D7-505AD9A59CD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50635" t="95866" r="48121" b="2004"/>
            <a:stretch>
              <a:fillRect/>
            </a:stretch>
          </p:blipFill>
          <p:spPr>
            <a:xfrm>
              <a:off x="676308" y="3192834"/>
              <a:ext cx="380489" cy="472331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DF540BC2-3E0F-01A6-0C44-4983EC8FBCCD}"/>
                </a:ext>
              </a:extLst>
            </p:cNvPr>
            <p:cNvSpPr txBox="1"/>
            <p:nvPr/>
          </p:nvSpPr>
          <p:spPr>
            <a:xfrm>
              <a:off x="1067429" y="3267807"/>
              <a:ext cx="4271619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/>
                <a:t>Alteration ( pre vs. post </a:t>
              </a:r>
              <a:r>
                <a:rPr lang="en-US" dirty="0" err="1"/>
                <a:t>chemoirradiation</a:t>
              </a:r>
              <a:r>
                <a:rPr lang="en-US" dirty="0"/>
                <a:t>)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88A51A9-6F9A-E444-9406-F950C3DEE44F}"/>
                </a:ext>
              </a:extLst>
            </p:cNvPr>
            <p:cNvSpPr txBox="1"/>
            <p:nvPr/>
          </p:nvSpPr>
          <p:spPr>
            <a:xfrm>
              <a:off x="1067430" y="2891714"/>
              <a:ext cx="3351367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dirty="0"/>
                <a:t>Baseline ( pre </a:t>
              </a:r>
              <a:r>
                <a:rPr lang="en-US" dirty="0" err="1"/>
                <a:t>chemoirradiation</a:t>
              </a:r>
              <a:r>
                <a:rPr lang="en-US" dirty="0"/>
                <a:t>)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908224BE-749D-734D-3ACA-01488F3EF39C}"/>
              </a:ext>
            </a:extLst>
          </p:cNvPr>
          <p:cNvSpPr txBox="1"/>
          <p:nvPr/>
        </p:nvSpPr>
        <p:spPr>
          <a:xfrm>
            <a:off x="263659" y="6221851"/>
            <a:ext cx="1192834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l Figure 2.</a:t>
            </a:r>
            <a:r>
              <a:rPr lang="en-US" sz="12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chemeClr val="bg2">
                    <a:lumMod val="10000"/>
                  </a:schemeClr>
                </a:solidFill>
              </a:rPr>
              <a:t>Differentially expressed proteins and compounds adjusted by age, VPA and GTV T1 in association with OS, PFS, MGMT status, IDH status. Baseline signal is blue (pre </a:t>
            </a:r>
            <a:r>
              <a:rPr lang="en-US" sz="1200" dirty="0" err="1">
                <a:solidFill>
                  <a:schemeClr val="bg2">
                    <a:lumMod val="10000"/>
                  </a:schemeClr>
                </a:solidFill>
              </a:rPr>
              <a:t>chemoirradiation</a:t>
            </a:r>
            <a:r>
              <a:rPr lang="en-US" sz="1200" dirty="0">
                <a:solidFill>
                  <a:schemeClr val="bg2">
                    <a:lumMod val="10000"/>
                  </a:schemeClr>
                </a:solidFill>
              </a:rPr>
              <a:t>), alteration (pre vs. post </a:t>
            </a:r>
            <a:r>
              <a:rPr lang="en-US" sz="1200" dirty="0" err="1">
                <a:solidFill>
                  <a:schemeClr val="bg2">
                    <a:lumMod val="10000"/>
                  </a:schemeClr>
                </a:solidFill>
              </a:rPr>
              <a:t>chemoirradiation</a:t>
            </a:r>
            <a:r>
              <a:rPr lang="en-US" sz="1200" dirty="0">
                <a:solidFill>
                  <a:schemeClr val="bg2">
                    <a:lumMod val="10000"/>
                  </a:schemeClr>
                </a:solidFill>
              </a:rPr>
              <a:t> signal is orange). Compounds designated with level 1 confidence annotation are listed additionally in the right aspect of the figure.</a:t>
            </a:r>
          </a:p>
        </p:txBody>
      </p:sp>
    </p:spTree>
    <p:extLst>
      <p:ext uri="{BB962C8B-B14F-4D97-AF65-F5344CB8AC3E}">
        <p14:creationId xmlns:p14="http://schemas.microsoft.com/office/powerpoint/2010/main" val="2344804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100</Words>
  <Application>Microsoft Macintosh PowerPoint</Application>
  <PresentationFormat>Widescreen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rauze, Andra (NIH/NCI) [E]</dc:creator>
  <cp:lastModifiedBy>Krauze, Andra (NIH/NCI) [E]</cp:lastModifiedBy>
  <cp:revision>6</cp:revision>
  <dcterms:created xsi:type="dcterms:W3CDTF">2025-08-22T16:46:46Z</dcterms:created>
  <dcterms:modified xsi:type="dcterms:W3CDTF">2025-10-28T20:39:20Z</dcterms:modified>
</cp:coreProperties>
</file>